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C10DC2-6CCF-46D6-BF05-E02538C32552}" v="12" dt="2022-03-02T16:36:32.0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59" d="100"/>
          <a:sy n="59" d="100"/>
        </p:scale>
        <p:origin x="630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MILA OSPINA AYALA" userId="78f2fe8b-a352-4d21-8a73-8c582c191c8b" providerId="ADAL" clId="{B2C10DC2-6CCF-46D6-BF05-E02538C32552}"/>
    <pc:docChg chg="undo custSel modSld">
      <pc:chgData name="CAMILA OSPINA AYALA" userId="78f2fe8b-a352-4d21-8a73-8c582c191c8b" providerId="ADAL" clId="{B2C10DC2-6CCF-46D6-BF05-E02538C32552}" dt="2022-03-02T18:50:43.044" v="120" actId="20577"/>
      <pc:docMkLst>
        <pc:docMk/>
      </pc:docMkLst>
      <pc:sldChg chg="addSp delSp modSp mod">
        <pc:chgData name="CAMILA OSPINA AYALA" userId="78f2fe8b-a352-4d21-8a73-8c582c191c8b" providerId="ADAL" clId="{B2C10DC2-6CCF-46D6-BF05-E02538C32552}" dt="2022-03-02T18:50:43.044" v="120" actId="20577"/>
        <pc:sldMkLst>
          <pc:docMk/>
          <pc:sldMk cId="3513509246" sldId="256"/>
        </pc:sldMkLst>
        <pc:spChg chg="add del mod">
          <ac:chgData name="CAMILA OSPINA AYALA" userId="78f2fe8b-a352-4d21-8a73-8c582c191c8b" providerId="ADAL" clId="{B2C10DC2-6CCF-46D6-BF05-E02538C32552}" dt="2022-03-02T16:35:56.943" v="107" actId="20577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19" creationId="{AC4C3DC5-C950-4469-B152-4E43DE1B5036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1" creationId="{1CA3E8AA-CACE-4939-89EE-2E2C569FA7D2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3" creationId="{2223FC15-4D9E-4B6E-8A58-F6F5B19D2659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5" creationId="{599088B4-5A7A-4909-B659-A569413595EE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6" creationId="{000E1D5E-750D-4A86-887D-B8AE804C8B3B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7" creationId="{EDE3F7CC-9264-4DB8-90A9-8EF5F9D9F236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8" creationId="{4932058E-A20F-4F48-953C-EDBFFCE96125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B2C10DC2-6CCF-46D6-BF05-E02538C32552}" dt="2022-03-02T16:35:37.532" v="85" actId="20577"/>
          <ac:spMkLst>
            <pc:docMk/>
            <pc:sldMk cId="3513509246" sldId="256"/>
            <ac:spMk id="32" creationId="{F663FA82-1B76-4B5E-939C-AED05F0BEF2C}"/>
          </ac:spMkLst>
        </pc:spChg>
        <pc:spChg chg="del mod">
          <ac:chgData name="CAMILA OSPINA AYALA" userId="78f2fe8b-a352-4d21-8a73-8c582c191c8b" providerId="ADAL" clId="{B2C10DC2-6CCF-46D6-BF05-E02538C32552}" dt="2022-03-02T16:35:51.862" v="91" actId="478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34" creationId="{0CE25098-89F7-4813-B544-78663C75256E}"/>
          </ac:spMkLst>
        </pc:spChg>
        <pc:spChg chg="mod">
          <ac:chgData name="CAMILA OSPINA AYALA" userId="78f2fe8b-a352-4d21-8a73-8c582c191c8b" providerId="ADAL" clId="{B2C10DC2-6CCF-46D6-BF05-E02538C32552}" dt="2022-03-02T12:05:56.796" v="15" actId="165"/>
          <ac:spMkLst>
            <pc:docMk/>
            <pc:sldMk cId="3513509246" sldId="256"/>
            <ac:spMk id="35" creationId="{2843D0DD-7137-4E59-8F50-E9A10B68152C}"/>
          </ac:spMkLst>
        </pc:spChg>
        <pc:spChg chg="add mod">
          <ac:chgData name="CAMILA OSPINA AYALA" userId="78f2fe8b-a352-4d21-8a73-8c582c191c8b" providerId="ADAL" clId="{B2C10DC2-6CCF-46D6-BF05-E02538C32552}" dt="2022-03-02T12:07:40.185" v="30" actId="255"/>
          <ac:spMkLst>
            <pc:docMk/>
            <pc:sldMk cId="3513509246" sldId="256"/>
            <ac:spMk id="37" creationId="{6DA1AC4B-49B1-439A-9BDE-C7CC8AA080D5}"/>
          </ac:spMkLst>
        </pc:spChg>
        <pc:spChg chg="add mod">
          <ac:chgData name="CAMILA OSPINA AYALA" userId="78f2fe8b-a352-4d21-8a73-8c582c191c8b" providerId="ADAL" clId="{B2C10DC2-6CCF-46D6-BF05-E02538C32552}" dt="2022-03-02T18:50:43.044" v="120" actId="20577"/>
          <ac:spMkLst>
            <pc:docMk/>
            <pc:sldMk cId="3513509246" sldId="256"/>
            <ac:spMk id="38" creationId="{821799B0-D045-463D-A736-27F3732BE75E}"/>
          </ac:spMkLst>
        </pc:spChg>
        <pc:spChg chg="add mod">
          <ac:chgData name="CAMILA OSPINA AYALA" userId="78f2fe8b-a352-4d21-8a73-8c582c191c8b" providerId="ADAL" clId="{B2C10DC2-6CCF-46D6-BF05-E02538C32552}" dt="2022-03-02T16:34:36.585" v="50" actId="164"/>
          <ac:spMkLst>
            <pc:docMk/>
            <pc:sldMk cId="3513509246" sldId="256"/>
            <ac:spMk id="39" creationId="{C6491DAB-A5F0-494D-AC30-8B732D26F461}"/>
          </ac:spMkLst>
        </pc:spChg>
        <pc:spChg chg="add mod">
          <ac:chgData name="CAMILA OSPINA AYALA" userId="78f2fe8b-a352-4d21-8a73-8c582c191c8b" providerId="ADAL" clId="{B2C10DC2-6CCF-46D6-BF05-E02538C32552}" dt="2022-03-02T16:35:10.425" v="57" actId="164"/>
          <ac:spMkLst>
            <pc:docMk/>
            <pc:sldMk cId="3513509246" sldId="256"/>
            <ac:spMk id="40" creationId="{1A777C1C-89CF-484A-919C-9EECD3FABC4B}"/>
          </ac:spMkLst>
        </pc:spChg>
        <pc:spChg chg="add mod">
          <ac:chgData name="CAMILA OSPINA AYALA" userId="78f2fe8b-a352-4d21-8a73-8c582c191c8b" providerId="ADAL" clId="{B2C10DC2-6CCF-46D6-BF05-E02538C32552}" dt="2022-03-02T16:36:32.019" v="115" actId="164"/>
          <ac:spMkLst>
            <pc:docMk/>
            <pc:sldMk cId="3513509246" sldId="256"/>
            <ac:spMk id="41" creationId="{E8A81436-72F3-4CB4-A547-1F9C42D619E7}"/>
          </ac:spMkLst>
        </pc:spChg>
        <pc:grpChg chg="add mod topLvl">
          <ac:chgData name="CAMILA OSPINA AYALA" userId="78f2fe8b-a352-4d21-8a73-8c582c191c8b" providerId="ADAL" clId="{B2C10DC2-6CCF-46D6-BF05-E02538C32552}" dt="2022-03-02T16:39:42.948" v="118" actId="14100"/>
          <ac:grpSpMkLst>
            <pc:docMk/>
            <pc:sldMk cId="3513509246" sldId="256"/>
            <ac:grpSpMk id="2" creationId="{594D61B9-3BA0-4F87-A8F1-532C98C4773D}"/>
          </ac:grpSpMkLst>
        </pc:grpChg>
        <pc:grpChg chg="add del mod">
          <ac:chgData name="CAMILA OSPINA AYALA" userId="78f2fe8b-a352-4d21-8a73-8c582c191c8b" providerId="ADAL" clId="{B2C10DC2-6CCF-46D6-BF05-E02538C32552}" dt="2022-03-02T12:05:56.796" v="15" actId="165"/>
          <ac:grpSpMkLst>
            <pc:docMk/>
            <pc:sldMk cId="3513509246" sldId="256"/>
            <ac:grpSpMk id="5" creationId="{CC8B4A38-86A6-482A-BD85-BD27758BAFB2}"/>
          </ac:grpSpMkLst>
        </pc:grpChg>
        <pc:grpChg chg="add mod">
          <ac:chgData name="CAMILA OSPINA AYALA" userId="78f2fe8b-a352-4d21-8a73-8c582c191c8b" providerId="ADAL" clId="{B2C10DC2-6CCF-46D6-BF05-E02538C32552}" dt="2022-03-02T16:35:10.425" v="57" actId="164"/>
          <ac:grpSpMkLst>
            <pc:docMk/>
            <pc:sldMk cId="3513509246" sldId="256"/>
            <ac:grpSpMk id="6" creationId="{62F7133E-9D1E-408F-8700-69A41E61366C}"/>
          </ac:grpSpMkLst>
        </pc:grpChg>
        <pc:grpChg chg="add mod">
          <ac:chgData name="CAMILA OSPINA AYALA" userId="78f2fe8b-a352-4d21-8a73-8c582c191c8b" providerId="ADAL" clId="{B2C10DC2-6CCF-46D6-BF05-E02538C32552}" dt="2022-03-02T16:36:41.115" v="117" actId="12789"/>
          <ac:grpSpMkLst>
            <pc:docMk/>
            <pc:sldMk cId="3513509246" sldId="256"/>
            <ac:grpSpMk id="7" creationId="{D8E69FC1-F40F-425C-B16F-ED5EE861CAF2}"/>
          </ac:grpSpMkLst>
        </pc:grpChg>
        <pc:grpChg chg="add mod">
          <ac:chgData name="CAMILA OSPINA AYALA" userId="78f2fe8b-a352-4d21-8a73-8c582c191c8b" providerId="ADAL" clId="{B2C10DC2-6CCF-46D6-BF05-E02538C32552}" dt="2022-03-02T16:36:41.115" v="117" actId="12789"/>
          <ac:grpSpMkLst>
            <pc:docMk/>
            <pc:sldMk cId="3513509246" sldId="256"/>
            <ac:grpSpMk id="8" creationId="{08FC95A8-41EE-414E-8767-3508C3512806}"/>
          </ac:grpSpMkLst>
        </pc:grpChg>
        <pc:grpChg chg="mod topLvl">
          <ac:chgData name="CAMILA OSPINA AYALA" userId="78f2fe8b-a352-4d21-8a73-8c582c191c8b" providerId="ADAL" clId="{B2C10DC2-6CCF-46D6-BF05-E02538C32552}" dt="2022-03-02T16:36:32.019" v="115" actId="164"/>
          <ac:grpSpMkLst>
            <pc:docMk/>
            <pc:sldMk cId="3513509246" sldId="256"/>
            <ac:grpSpMk id="15" creationId="{7E83C65F-6016-4224-B46D-4B3AC52081C9}"/>
          </ac:grpSpMkLst>
        </pc:grpChg>
        <pc:grpChg chg="add del mod topLvl">
          <ac:chgData name="CAMILA OSPINA AYALA" userId="78f2fe8b-a352-4d21-8a73-8c582c191c8b" providerId="ADAL" clId="{B2C10DC2-6CCF-46D6-BF05-E02538C32552}" dt="2022-03-02T16:35:40.202" v="86" actId="478"/>
          <ac:grpSpMkLst>
            <pc:docMk/>
            <pc:sldMk cId="3513509246" sldId="256"/>
            <ac:grpSpMk id="16" creationId="{5BD62117-51CC-49FD-9B14-D0BD3D7E5606}"/>
          </ac:grpSpMkLst>
        </pc:grpChg>
        <pc:picChg chg="add del mod">
          <ac:chgData name="CAMILA OSPINA AYALA" userId="78f2fe8b-a352-4d21-8a73-8c582c191c8b" providerId="ADAL" clId="{B2C10DC2-6CCF-46D6-BF05-E02538C32552}" dt="2022-03-02T16:36:04.577" v="108" actId="478"/>
          <ac:picMkLst>
            <pc:docMk/>
            <pc:sldMk cId="3513509246" sldId="256"/>
            <ac:picMk id="3" creationId="{2748FDED-478B-4CD4-B3DF-3EB6DA924E4F}"/>
          </ac:picMkLst>
        </pc:picChg>
        <pc:picChg chg="add del mod">
          <ac:chgData name="CAMILA OSPINA AYALA" userId="78f2fe8b-a352-4d21-8a73-8c582c191c8b" providerId="ADAL" clId="{B2C10DC2-6CCF-46D6-BF05-E02538C32552}" dt="2022-03-02T12:04:31.726" v="7" actId="478"/>
          <ac:picMkLst>
            <pc:docMk/>
            <pc:sldMk cId="3513509246" sldId="256"/>
            <ac:picMk id="4" creationId="{E927BDED-F7F8-4118-95A6-5DD1716F8A88}"/>
          </ac:picMkLst>
        </pc:picChg>
        <pc:picChg chg="add mod modCrop">
          <ac:chgData name="CAMILA OSPINA AYALA" userId="78f2fe8b-a352-4d21-8a73-8c582c191c8b" providerId="ADAL" clId="{B2C10DC2-6CCF-46D6-BF05-E02538C32552}" dt="2022-03-02T16:34:36.585" v="50" actId="164"/>
          <ac:picMkLst>
            <pc:docMk/>
            <pc:sldMk cId="3513509246" sldId="256"/>
            <ac:picMk id="5" creationId="{BCD75B21-B181-455E-951F-C230AAA345A3}"/>
          </ac:picMkLst>
        </pc:picChg>
        <pc:picChg chg="mod">
          <ac:chgData name="CAMILA OSPINA AYALA" userId="78f2fe8b-a352-4d21-8a73-8c582c191c8b" providerId="ADAL" clId="{B2C10DC2-6CCF-46D6-BF05-E02538C32552}" dt="2022-03-02T12:05:56.796" v="15" actId="165"/>
          <ac:picMkLst>
            <pc:docMk/>
            <pc:sldMk cId="3513509246" sldId="256"/>
            <ac:picMk id="18" creationId="{5E2E3BE4-D8DF-45CE-80E8-69E01C751179}"/>
          </ac:picMkLst>
        </pc:picChg>
        <pc:picChg chg="add del mod topLvl">
          <ac:chgData name="CAMILA OSPINA AYALA" userId="78f2fe8b-a352-4d21-8a73-8c582c191c8b" providerId="ADAL" clId="{B2C10DC2-6CCF-46D6-BF05-E02538C32552}" dt="2022-03-02T16:35:40.202" v="86" actId="478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B2C10DC2-6CCF-46D6-BF05-E02538C32552}" dt="2022-03-02T12:05:56.796" v="15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B2C10DC2-6CCF-46D6-BF05-E02538C32552}" dt="2022-03-02T16:35:46.761" v="89" actId="1076"/>
          <ac:picMkLst>
            <pc:docMk/>
            <pc:sldMk cId="3513509246" sldId="256"/>
            <ac:picMk id="24" creationId="{53327AEA-8B5E-4FB8-94DB-CA62964753AB}"/>
          </ac:picMkLst>
        </pc:picChg>
        <pc:picChg chg="add del mod ord topLvl modCrop">
          <ac:chgData name="CAMILA OSPINA AYALA" userId="78f2fe8b-a352-4d21-8a73-8c582c191c8b" providerId="ADAL" clId="{B2C10DC2-6CCF-46D6-BF05-E02538C32552}" dt="2022-03-02T16:33:20.845" v="34" actId="478"/>
          <ac:picMkLst>
            <pc:docMk/>
            <pc:sldMk cId="3513509246" sldId="256"/>
            <ac:picMk id="36" creationId="{975B13EB-2C51-4B8B-BC3B-B3ABDDB8B13D}"/>
          </ac:picMkLst>
        </pc:picChg>
      </pc:sldChg>
    </pc:docChg>
  </pc:docChgLst>
  <pc:docChgLst>
    <pc:chgData name="CAMILA OSPINA AYALA" userId="78f2fe8b-a352-4d21-8a73-8c582c191c8b" providerId="ADAL" clId="{187911B5-20BD-4C8F-B5D0-28267442506B}"/>
    <pc:docChg chg="undo custSel modSld">
      <pc:chgData name="CAMILA OSPINA AYALA" userId="78f2fe8b-a352-4d21-8a73-8c582c191c8b" providerId="ADAL" clId="{187911B5-20BD-4C8F-B5D0-28267442506B}" dt="2022-02-24T21:33:26.034" v="326" actId="165"/>
      <pc:docMkLst>
        <pc:docMk/>
      </pc:docMkLst>
      <pc:sldChg chg="addSp delSp modSp mod">
        <pc:chgData name="CAMILA OSPINA AYALA" userId="78f2fe8b-a352-4d21-8a73-8c582c191c8b" providerId="ADAL" clId="{187911B5-20BD-4C8F-B5D0-28267442506B}" dt="2022-02-24T21:33:26.034" v="326" actId="165"/>
        <pc:sldMkLst>
          <pc:docMk/>
          <pc:sldMk cId="3513509246" sldId="256"/>
        </pc:sldMkLst>
        <pc:spChg chg="mod">
          <ac:chgData name="CAMILA OSPINA AYALA" userId="78f2fe8b-a352-4d21-8a73-8c582c191c8b" providerId="ADAL" clId="{187911B5-20BD-4C8F-B5D0-28267442506B}" dt="2022-02-24T21:23:24.298" v="14" actId="1076"/>
          <ac:spMkLst>
            <pc:docMk/>
            <pc:sldMk cId="3513509246" sldId="256"/>
            <ac:spMk id="14" creationId="{559545BB-4BA5-4679-B338-FBC782E75B16}"/>
          </ac:spMkLst>
        </pc:spChg>
        <pc:spChg chg="add del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19" creationId="{AC4C3DC5-C950-4469-B152-4E43DE1B50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1" creationId="{1CA3E8AA-CACE-4939-89EE-2E2C569FA7D2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3" creationId="{2223FC15-4D9E-4B6E-8A58-F6F5B19D2659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5" creationId="{599088B4-5A7A-4909-B659-A569413595E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6" creationId="{000E1D5E-750D-4A86-887D-B8AE804C8B3B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7" creationId="{EDE3F7CC-9264-4DB8-90A9-8EF5F9D9F2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8" creationId="{4932058E-A20F-4F48-953C-EDBFFCE96125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9" creationId="{5751DFF6-0BE3-49DA-9152-418AC0EC220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4" creationId="{0CE25098-89F7-4813-B544-78663C75256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5" creationId="{2843D0DD-7137-4E59-8F50-E9A10B68152C}"/>
          </ac:spMkLst>
        </pc:spChg>
        <pc:grpChg chg="add del mod">
          <ac:chgData name="CAMILA OSPINA AYALA" userId="78f2fe8b-a352-4d21-8a73-8c582c191c8b" providerId="ADAL" clId="{187911B5-20BD-4C8F-B5D0-28267442506B}" dt="2022-02-24T21:30:56.916" v="282" actId="165"/>
          <ac:grpSpMkLst>
            <pc:docMk/>
            <pc:sldMk cId="3513509246" sldId="256"/>
            <ac:grpSpMk id="5" creationId="{006DE612-4C2B-4E1B-B82E-F339281C75D5}"/>
          </ac:grpSpMkLst>
        </pc:grpChg>
        <pc:grpChg chg="add del mod">
          <ac:chgData name="CAMILA OSPINA AYALA" userId="78f2fe8b-a352-4d21-8a73-8c582c191c8b" providerId="ADAL" clId="{187911B5-20BD-4C8F-B5D0-28267442506B}" dt="2022-02-24T21:32:43.805" v="316" actId="165"/>
          <ac:grpSpMkLst>
            <pc:docMk/>
            <pc:sldMk cId="3513509246" sldId="256"/>
            <ac:grpSpMk id="6" creationId="{A0A96CC2-E922-4833-B114-2553F37C9A33}"/>
          </ac:grpSpMkLst>
        </pc:grpChg>
        <pc:grpChg chg="add del mod">
          <ac:chgData name="CAMILA OSPINA AYALA" userId="78f2fe8b-a352-4d21-8a73-8c582c191c8b" providerId="ADAL" clId="{187911B5-20BD-4C8F-B5D0-28267442506B}" dt="2022-02-24T21:33:26.034" v="326" actId="165"/>
          <ac:grpSpMkLst>
            <pc:docMk/>
            <pc:sldMk cId="3513509246" sldId="256"/>
            <ac:grpSpMk id="7" creationId="{70B8AE92-9F7E-43B5-9888-4C997963DB39}"/>
          </ac:grpSpMkLst>
        </pc:grpChg>
        <pc:picChg chg="add mod modCrop">
          <ac:chgData name="CAMILA OSPINA AYALA" userId="78f2fe8b-a352-4d21-8a73-8c582c191c8b" providerId="ADAL" clId="{187911B5-20BD-4C8F-B5D0-28267442506B}" dt="2022-02-24T21:32:03.241" v="310" actId="1076"/>
          <ac:picMkLst>
            <pc:docMk/>
            <pc:sldMk cId="3513509246" sldId="256"/>
            <ac:picMk id="4" creationId="{E927BDED-F7F8-4118-95A6-5DD1716F8A88}"/>
          </ac:picMkLst>
        </pc:picChg>
        <pc:picChg chg="del">
          <ac:chgData name="CAMILA OSPINA AYALA" userId="78f2fe8b-a352-4d21-8a73-8c582c191c8b" providerId="ADAL" clId="{187911B5-20BD-4C8F-B5D0-28267442506B}" dt="2022-02-24T21:21:00.561" v="1" actId="478"/>
          <ac:picMkLst>
            <pc:docMk/>
            <pc:sldMk cId="3513509246" sldId="256"/>
            <ac:picMk id="13" creationId="{3528E06E-326A-4332-977C-BC054873EE2B}"/>
          </ac:picMkLst>
        </pc:picChg>
        <pc:picChg chg="add del mod modCrop">
          <ac:chgData name="CAMILA OSPINA AYALA" userId="78f2fe8b-a352-4d21-8a73-8c582c191c8b" providerId="ADAL" clId="{187911B5-20BD-4C8F-B5D0-28267442506B}" dt="2022-02-24T21:21:40.512" v="13" actId="478"/>
          <ac:picMkLst>
            <pc:docMk/>
            <pc:sldMk cId="3513509246" sldId="256"/>
            <ac:picMk id="17" creationId="{618A0970-9F8E-486E-9464-E7FFFE0AADF9}"/>
          </ac:picMkLst>
        </pc:picChg>
      </pc:sldChg>
    </pc:docChg>
  </pc:docChgLst>
  <pc:docChgLst>
    <pc:chgData name="CAMILA OSPINA AYALA" userId="78f2fe8b-a352-4d21-8a73-8c582c191c8b" providerId="ADAL" clId="{AB7D9840-CA5B-4FFC-A813-372B7C481899}"/>
    <pc:docChg chg="undo custSel modSld">
      <pc:chgData name="CAMILA OSPINA AYALA" userId="78f2fe8b-a352-4d21-8a73-8c582c191c8b" providerId="ADAL" clId="{AB7D9840-CA5B-4FFC-A813-372B7C481899}" dt="2021-11-09T13:47:23.937" v="78" actId="14100"/>
      <pc:docMkLst>
        <pc:docMk/>
      </pc:docMkLst>
      <pc:sldChg chg="addSp delSp modSp">
        <pc:chgData name="CAMILA OSPINA AYALA" userId="78f2fe8b-a352-4d21-8a73-8c582c191c8b" providerId="ADAL" clId="{AB7D9840-CA5B-4FFC-A813-372B7C481899}" dt="2021-11-09T13:47:23.937" v="78" actId="14100"/>
        <pc:sldMkLst>
          <pc:docMk/>
          <pc:sldMk cId="3513509246" sldId="256"/>
        </pc:sldMkLst>
        <pc:spChg chg="add mod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0" creationId="{F3C4E3DD-1D10-4D5A-81CD-763ECE650A65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1" creationId="{07AE9398-1881-469F-951D-29ADA2B178B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2" creationId="{F663FA82-1B76-4B5E-939C-AED05F0BEF2C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3" creationId="{44C6A6F1-68BE-4290-B0AA-CE94068E701A}"/>
          </ac:spMkLst>
        </pc:spChg>
        <pc:grpChg chg="del">
          <ac:chgData name="CAMILA OSPINA AYALA" userId="78f2fe8b-a352-4d21-8a73-8c582c191c8b" providerId="ADAL" clId="{AB7D9840-CA5B-4FFC-A813-372B7C481899}" dt="2021-11-09T13:40:49.942" v="9" actId="165"/>
          <ac:grpSpMkLst>
            <pc:docMk/>
            <pc:sldMk cId="3513509246" sldId="256"/>
            <ac:grpSpMk id="4" creationId="{8765459E-59E5-41B9-B49C-6C3B9E76EF99}"/>
          </ac:grpSpMkLst>
        </pc:grpChg>
        <pc:grpChg chg="add mod or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5" creationId="{7E83C65F-6016-4224-B46D-4B3AC52081C9}"/>
          </ac:grpSpMkLst>
        </pc:grpChg>
        <pc:grpChg chg="add mo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6" creationId="{5BD62117-51CC-49FD-9B14-D0BD3D7E5606}"/>
          </ac:grpSpMkLst>
        </pc:grpChg>
        <pc:picChg chg="add mod modCrop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AB7D9840-CA5B-4FFC-A813-372B7C481899}" dt="2021-11-09T13:41:50.045" v="42" actId="478"/>
          <ac:picMkLst>
            <pc:docMk/>
            <pc:sldMk cId="3513509246" sldId="256"/>
            <ac:picMk id="5" creationId="{6CF85439-18F4-496C-B123-F523870D85F2}"/>
          </ac:picMkLst>
        </pc:picChg>
        <pc:picChg chg="add del mod">
          <ac:chgData name="CAMILA OSPINA AYALA" userId="78f2fe8b-a352-4d21-8a73-8c582c191c8b" providerId="ADAL" clId="{AB7D9840-CA5B-4FFC-A813-372B7C481899}" dt="2021-11-09T13:42:08.734" v="44" actId="478"/>
          <ac:picMkLst>
            <pc:docMk/>
            <pc:sldMk cId="3513509246" sldId="256"/>
            <ac:picMk id="7" creationId="{BD85E238-25E4-4118-9D82-95D7D004AFBD}"/>
          </ac:picMkLst>
        </pc:picChg>
        <pc:picChg chg="add del mod">
          <ac:chgData name="CAMILA OSPINA AYALA" userId="78f2fe8b-a352-4d21-8a73-8c582c191c8b" providerId="ADAL" clId="{AB7D9840-CA5B-4FFC-A813-372B7C481899}" dt="2021-11-09T13:42:31.880" v="47" actId="478"/>
          <ac:picMkLst>
            <pc:docMk/>
            <pc:sldMk cId="3513509246" sldId="256"/>
            <ac:picMk id="9" creationId="{D8BD357C-3D06-4ECE-809D-6CEC56736D79}"/>
          </ac:picMkLst>
        </pc:picChg>
        <pc:picChg chg="add del mod">
          <ac:chgData name="CAMILA OSPINA AYALA" userId="78f2fe8b-a352-4d21-8a73-8c582c191c8b" providerId="ADAL" clId="{AB7D9840-CA5B-4FFC-A813-372B7C481899}" dt="2021-11-09T13:42:57" v="50" actId="478"/>
          <ac:picMkLst>
            <pc:docMk/>
            <pc:sldMk cId="3513509246" sldId="256"/>
            <ac:picMk id="11" creationId="{C95944BA-BEA0-444F-869D-085F7F6C5139}"/>
          </ac:picMkLst>
        </pc:picChg>
        <pc:picChg chg="add mod modCrop">
          <ac:chgData name="CAMILA OSPINA AYALA" userId="78f2fe8b-a352-4d21-8a73-8c582c191c8b" providerId="ADAL" clId="{AB7D9840-CA5B-4FFC-A813-372B7C481899}" dt="2021-11-09T13:47:23.937" v="78" actId="14100"/>
          <ac:picMkLst>
            <pc:docMk/>
            <pc:sldMk cId="3513509246" sldId="256"/>
            <ac:picMk id="13" creationId="{3528E06E-326A-4332-977C-BC054873EE2B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18" creationId="{5E2E3BE4-D8DF-45CE-80E8-69E01C751179}"/>
          </ac:picMkLst>
        </pc:picChg>
        <pc:picChg chg="mod topLvl">
          <ac:chgData name="CAMILA OSPINA AYALA" userId="78f2fe8b-a352-4d21-8a73-8c582c191c8b" providerId="ADAL" clId="{AB7D9840-CA5B-4FFC-A813-372B7C481899}" dt="2021-11-09T13:47:14.087" v="75" actId="164"/>
          <ac:picMkLst>
            <pc:docMk/>
            <pc:sldMk cId="3513509246" sldId="256"/>
            <ac:picMk id="20" creationId="{D2B966CF-BD00-4476-8C77-EE159EC54D2D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2" creationId="{36557F51-4591-406D-A74B-AA0F86974730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4" creationId="{53327AEA-8B5E-4FB8-94DB-CA62964753A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441A61-7D5C-4C1E-98C6-A7A05559FB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C893DF5-944C-4E2F-A0D4-433B9C9AA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B69738-C9FF-4A89-8EB5-DBC3DE97B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16A829-1469-4926-951D-D150FD12D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0E1E362-0F51-4FED-8503-4C04FE575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0281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98890-C06A-41C7-A3BE-289EE5620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2D998D7E-2AAF-455E-8EB4-3521F9D162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FBB33E8-8A0F-4070-84CC-CBDB4ECAB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62D9E2C-8F7C-4F95-B296-AFFDC6DFD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4EB4553-B907-42B7-A342-DE03F09AA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4434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2D1814-E652-4763-959B-5B3D0076D9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A87DACC-56C5-43D2-A8CB-659FEE9DC4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1154AC2-BB19-42A6-A5D0-B4B1F5E98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2955D94-8EC9-4B05-8ED6-49284BC64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3F76BC-BD1D-4447-A01A-EB14F7C04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017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7B74B9-1236-4EF6-A2AD-FBD77A29E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55FFCA8-39E7-4850-8B00-4103A9F266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724F01F-4C4D-46EB-BDB2-704D45F6A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61BD0A-4F59-49F2-8D26-159445E53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46113C-A1F6-4A75-A594-3BE8145DD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69880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F70D6-8B5D-4ED4-8971-699B0D180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A89B727-33B6-4EBF-8A8C-A068D02DEC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854AAE-044C-4F7B-B179-122D28F19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FEF864D-E39B-4EBA-ADB0-6FC8F80A2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F7245A7-27CB-404F-9114-9EA9455E8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8844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0C124E-355C-4F2B-A267-D7147380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9ACBD224-AE35-49C8-8091-A0DF82B4BA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2476E06-9702-4449-9D7F-4D5B2C4DAA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97BEE62-1B25-492C-B3C9-784CB734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3D264FB-A64C-4422-98CF-5D52F951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BBD16AB-150D-49AD-A643-4719D0178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1570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FFFD2D-D51C-4B14-807E-BD69DF11E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718BFB2-3770-4AC7-82C4-C1DCD88A1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E93814FB-E5C9-497C-9CB4-8BF6554C99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96023B8-36E6-4CB5-9E41-F16635B128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86AFEA6-F7EE-40D3-8374-DC3E161389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73CD24C-BEEF-42DF-83F5-69BBF5C11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45B80B3A-789E-49A0-B0EB-4E8E1AF04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7457ED8-3AE6-4C6C-88F6-4EFA8683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289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098184-B0F1-4D9D-94E5-A5719A4E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C6DA878-F54E-449C-A4BB-B82806916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1B821EC-A481-4E3C-A71B-D045345CD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0F8B1289-AE6D-4409-B6BD-158A57831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227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3C05A06-C5BF-422A-B960-D0F65EE40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D5CD1DDB-EA0F-469A-B906-80B9969CE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51136C3-2EB9-4C4B-88C4-8903884DC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861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051EE3-341C-4883-8F06-C319E12C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AA2537E-3EC1-46E4-8FF1-55E94EA5A6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122A7DD-400B-4314-8235-2AEACD68E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B8DD15D-B411-438F-8E50-106643F96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304E1C5-DAC9-4E86-9847-4DD37040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1B275FA-A957-4003-99F7-D2E08B1BC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9979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D118D9-8C35-4ED7-BD2F-77DE5FD74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683050A-ABAB-475B-98D3-F8B43F1A7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B9D132FE-13F8-42D5-BCD8-9075CBD79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EB35309-1F4F-4D7F-B416-65F9F7377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8C6CB88-8BC5-4F7E-81CF-3DE646631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323CD44-AC7A-4A16-9622-EB8385E81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54674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01E297AD-1012-46EC-B217-7008C3B0F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AE9DCFF-2DF6-4C37-AE01-935A5D362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665C307-17D7-40CA-B656-ADC9854D1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62F454B-1DAC-4C5F-A0CE-CD5D2B1DBD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41D767-ADE0-4ED5-ABEB-74D5AD587C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193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mp"/><Relationship Id="rId5" Type="http://schemas.openxmlformats.org/officeDocument/2006/relationships/image" Target="../media/image4.tmp"/><Relationship Id="rId4" Type="http://schemas.openxmlformats.org/officeDocument/2006/relationships/image" Target="../media/image3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594D61B9-3BA0-4F87-A8F1-532C98C4773D}"/>
              </a:ext>
            </a:extLst>
          </p:cNvPr>
          <p:cNvGrpSpPr/>
          <p:nvPr/>
        </p:nvGrpSpPr>
        <p:grpSpPr>
          <a:xfrm>
            <a:off x="420846" y="721075"/>
            <a:ext cx="2022610" cy="4965547"/>
            <a:chOff x="304941" y="365796"/>
            <a:chExt cx="2022610" cy="5703699"/>
          </a:xfrm>
        </p:grpSpPr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AC4C3DC5-C950-4469-B152-4E43DE1B5036}"/>
                </a:ext>
              </a:extLst>
            </p:cNvPr>
            <p:cNvSpPr txBox="1"/>
            <p:nvPr/>
          </p:nvSpPr>
          <p:spPr>
            <a:xfrm>
              <a:off x="372664" y="365796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Translation process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1CA3E8AA-CACE-4939-89EE-2E2C569FA7D2}"/>
                </a:ext>
              </a:extLst>
            </p:cNvPr>
            <p:cNvSpPr txBox="1"/>
            <p:nvPr/>
          </p:nvSpPr>
          <p:spPr>
            <a:xfrm>
              <a:off x="372664" y="1012347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ontent validity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2223FC15-4D9E-4B6E-8A58-F6F5B19D2659}"/>
                </a:ext>
              </a:extLst>
            </p:cNvPr>
            <p:cNvSpPr txBox="1"/>
            <p:nvPr/>
          </p:nvSpPr>
          <p:spPr>
            <a:xfrm>
              <a:off x="372664" y="1658898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ypotheses testing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599088B4-5A7A-4909-B659-A569413595EE}"/>
                </a:ext>
              </a:extLst>
            </p:cNvPr>
            <p:cNvSpPr txBox="1"/>
            <p:nvPr/>
          </p:nvSpPr>
          <p:spPr>
            <a:xfrm>
              <a:off x="372664" y="2141238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tructural validity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000E1D5E-750D-4A86-887D-B8AE804C8B3B}"/>
                </a:ext>
              </a:extLst>
            </p:cNvPr>
            <p:cNvSpPr txBox="1"/>
            <p:nvPr/>
          </p:nvSpPr>
          <p:spPr>
            <a:xfrm>
              <a:off x="372664" y="2801820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riterion validity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EDE3F7CC-9264-4DB8-90A9-8EF5F9D9F236}"/>
                </a:ext>
              </a:extLst>
            </p:cNvPr>
            <p:cNvSpPr txBox="1"/>
            <p:nvPr/>
          </p:nvSpPr>
          <p:spPr>
            <a:xfrm>
              <a:off x="372664" y="3400730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ternal consistency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4932058E-A20F-4F48-953C-EDBFFCE96125}"/>
                </a:ext>
              </a:extLst>
            </p:cNvPr>
            <p:cNvSpPr txBox="1"/>
            <p:nvPr/>
          </p:nvSpPr>
          <p:spPr>
            <a:xfrm>
              <a:off x="372664" y="4017149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Reliability Test-retest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5751DFF6-0BE3-49DA-9152-418AC0EC2206}"/>
                </a:ext>
              </a:extLst>
            </p:cNvPr>
            <p:cNvSpPr txBox="1"/>
            <p:nvPr/>
          </p:nvSpPr>
          <p:spPr>
            <a:xfrm>
              <a:off x="304941" y="4616059"/>
              <a:ext cx="2022610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Measurement invariance 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0CE25098-89F7-4813-B544-78663C75256E}"/>
                </a:ext>
              </a:extLst>
            </p:cNvPr>
            <p:cNvSpPr txBox="1"/>
            <p:nvPr/>
          </p:nvSpPr>
          <p:spPr>
            <a:xfrm>
              <a:off x="372664" y="5220741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Responsiveness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5" name="CaixaDeTexto 34">
              <a:extLst>
                <a:ext uri="{FF2B5EF4-FFF2-40B4-BE49-F238E27FC236}">
                  <a16:creationId xmlns:a16="http://schemas.microsoft.com/office/drawing/2014/main" id="{2843D0DD-7137-4E59-8F50-E9A10B68152C}"/>
                </a:ext>
              </a:extLst>
            </p:cNvPr>
            <p:cNvSpPr txBox="1"/>
            <p:nvPr/>
          </p:nvSpPr>
          <p:spPr>
            <a:xfrm>
              <a:off x="372664" y="5753371"/>
              <a:ext cx="1887165" cy="316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verall</a:t>
              </a:r>
              <a:endParaRPr lang="pt-BR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6DA1AC4B-49B1-439A-9BDE-C7CC8AA080D5}"/>
              </a:ext>
            </a:extLst>
          </p:cNvPr>
          <p:cNvSpPr txBox="1"/>
          <p:nvPr/>
        </p:nvSpPr>
        <p:spPr>
          <a:xfrm>
            <a:off x="91553" y="5943408"/>
            <a:ext cx="1200889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5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X-axis represents the percentage of identified studies. </a:t>
            </a:r>
            <a:r>
              <a:rPr lang="en-CA" sz="1500" dirty="0">
                <a:latin typeface="Times New Roman" panose="02020603050405020304" pitchFamily="18" charset="0"/>
                <a:ea typeface="Calibri" panose="020F0502020204030204" pitchFamily="34" charset="0"/>
              </a:rPr>
              <a:t>Note: </a:t>
            </a:r>
            <a:r>
              <a:rPr lang="en-US" sz="1500" dirty="0">
                <a:latin typeface="Times New Roman" panose="02020603050405020304" pitchFamily="18" charset="0"/>
                <a:ea typeface="Calibri" panose="020F0502020204030204" pitchFamily="34" charset="0"/>
              </a:rPr>
              <a:t>hypotheses testing </a:t>
            </a:r>
            <a:r>
              <a:rPr lang="en-US" sz="1500" dirty="0">
                <a:latin typeface="Times New Roman" panose="02020603050405020304" pitchFamily="18" charset="0"/>
                <a:ea typeface="Calibri" panose="020F0502020204030204" pitchFamily="34" charset="0"/>
              </a:rPr>
              <a:t>considers </a:t>
            </a:r>
            <a:r>
              <a:rPr lang="en-US" sz="15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500" dirty="0">
                <a:latin typeface="Times New Roman" panose="02020603050405020304" pitchFamily="18" charset="0"/>
                <a:ea typeface="Calibri" panose="020F0502020204030204" pitchFamily="34" charset="0"/>
              </a:rPr>
              <a:t>criterion validity); structural validity considers (construct validity) and criterion </a:t>
            </a:r>
            <a:r>
              <a:rPr lang="en-US" sz="1500">
                <a:latin typeface="Times New Roman" panose="02020603050405020304" pitchFamily="18" charset="0"/>
                <a:ea typeface="Calibri" panose="020F0502020204030204" pitchFamily="34" charset="0"/>
              </a:rPr>
              <a:t>validity </a:t>
            </a:r>
            <a:r>
              <a:rPr lang="en-US" sz="1500">
                <a:latin typeface="Times New Roman" panose="02020603050405020304" pitchFamily="18" charset="0"/>
                <a:ea typeface="Calibri" panose="020F0502020204030204" pitchFamily="34" charset="0"/>
              </a:rPr>
              <a:t>considers </a:t>
            </a:r>
            <a:r>
              <a:rPr lang="en-US" sz="1500" dirty="0">
                <a:latin typeface="Times New Roman" panose="02020603050405020304" pitchFamily="18" charset="0"/>
                <a:ea typeface="Calibri" panose="020F0502020204030204" pitchFamily="34" charset="0"/>
              </a:rPr>
              <a:t>(diagnostic performance)</a:t>
            </a:r>
            <a:endParaRPr lang="pt-BR" sz="15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38" name="Retângulo 37">
            <a:extLst>
              <a:ext uri="{FF2B5EF4-FFF2-40B4-BE49-F238E27FC236}">
                <a16:creationId xmlns:a16="http://schemas.microsoft.com/office/drawing/2014/main" id="{821799B0-D045-463D-A736-27F3732BE75E}"/>
              </a:ext>
            </a:extLst>
          </p:cNvPr>
          <p:cNvSpPr/>
          <p:nvPr/>
        </p:nvSpPr>
        <p:spPr>
          <a:xfrm>
            <a:off x="707495" y="248693"/>
            <a:ext cx="9024461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le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sz="1600" b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SMIN methodological quality of original studies classification</a:t>
            </a:r>
            <a:endParaRPr lang="pt-B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Agrupar 6">
            <a:extLst>
              <a:ext uri="{FF2B5EF4-FFF2-40B4-BE49-F238E27FC236}">
                <a16:creationId xmlns:a16="http://schemas.microsoft.com/office/drawing/2014/main" id="{D8E69FC1-F40F-425C-B16F-ED5EE861CAF2}"/>
              </a:ext>
            </a:extLst>
          </p:cNvPr>
          <p:cNvGrpSpPr/>
          <p:nvPr/>
        </p:nvGrpSpPr>
        <p:grpSpPr>
          <a:xfrm>
            <a:off x="2591665" y="721075"/>
            <a:ext cx="7298254" cy="5304191"/>
            <a:chOff x="2591665" y="739785"/>
            <a:chExt cx="7298254" cy="5304191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62F7133E-9D1E-408F-8700-69A41E61366C}"/>
                </a:ext>
              </a:extLst>
            </p:cNvPr>
            <p:cNvGrpSpPr/>
            <p:nvPr/>
          </p:nvGrpSpPr>
          <p:grpSpPr>
            <a:xfrm>
              <a:off x="2591665" y="739785"/>
              <a:ext cx="7298254" cy="5304191"/>
              <a:chOff x="2591665" y="739785"/>
              <a:chExt cx="7298254" cy="5304191"/>
            </a:xfrm>
          </p:grpSpPr>
          <p:pic>
            <p:nvPicPr>
              <p:cNvPr id="5" name="Imagem 4" descr="Gráfico, Gráfico de barras&#10;&#10;Descrição gerada automaticamente">
                <a:extLst>
                  <a:ext uri="{FF2B5EF4-FFF2-40B4-BE49-F238E27FC236}">
                    <a16:creationId xmlns:a16="http://schemas.microsoft.com/office/drawing/2014/main" id="{BCD75B21-B181-455E-951F-C230AAA345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4397" b="1"/>
              <a:stretch/>
            </p:blipFill>
            <p:spPr>
              <a:xfrm>
                <a:off x="2591665" y="5237481"/>
                <a:ext cx="7298254" cy="806495"/>
              </a:xfrm>
              <a:prstGeom prst="rect">
                <a:avLst/>
              </a:prstGeom>
            </p:spPr>
          </p:pic>
          <p:sp>
            <p:nvSpPr>
              <p:cNvPr id="39" name="Retângulo 38">
                <a:extLst>
                  <a:ext uri="{FF2B5EF4-FFF2-40B4-BE49-F238E27FC236}">
                    <a16:creationId xmlns:a16="http://schemas.microsoft.com/office/drawing/2014/main" id="{C6491DAB-A5F0-494D-AC30-8B732D26F461}"/>
                  </a:ext>
                </a:extLst>
              </p:cNvPr>
              <p:cNvSpPr/>
              <p:nvPr/>
            </p:nvSpPr>
            <p:spPr>
              <a:xfrm>
                <a:off x="2818850" y="739785"/>
                <a:ext cx="6749220" cy="360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sp>
          <p:nvSpPr>
            <p:cNvPr id="40" name="Retângulo 39">
              <a:extLst>
                <a:ext uri="{FF2B5EF4-FFF2-40B4-BE49-F238E27FC236}">
                  <a16:creationId xmlns:a16="http://schemas.microsoft.com/office/drawing/2014/main" id="{1A777C1C-89CF-484A-919C-9EECD3FABC4B}"/>
                </a:ext>
              </a:extLst>
            </p:cNvPr>
            <p:cNvSpPr/>
            <p:nvPr/>
          </p:nvSpPr>
          <p:spPr>
            <a:xfrm>
              <a:off x="5517599" y="5285599"/>
              <a:ext cx="1351721" cy="335895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grpSp>
        <p:nvGrpSpPr>
          <p:cNvPr id="8" name="Agrupar 7">
            <a:extLst>
              <a:ext uri="{FF2B5EF4-FFF2-40B4-BE49-F238E27FC236}">
                <a16:creationId xmlns:a16="http://schemas.microsoft.com/office/drawing/2014/main" id="{08FC95A8-41EE-414E-8767-3508C3512806}"/>
              </a:ext>
            </a:extLst>
          </p:cNvPr>
          <p:cNvGrpSpPr/>
          <p:nvPr/>
        </p:nvGrpSpPr>
        <p:grpSpPr>
          <a:xfrm>
            <a:off x="10047624" y="2589868"/>
            <a:ext cx="2144376" cy="1566606"/>
            <a:chOff x="9889919" y="1930453"/>
            <a:chExt cx="2144376" cy="1566606"/>
          </a:xfrm>
        </p:grpSpPr>
        <p:grpSp>
          <p:nvGrpSpPr>
            <p:cNvPr id="15" name="Agrupar 14">
              <a:extLst>
                <a:ext uri="{FF2B5EF4-FFF2-40B4-BE49-F238E27FC236}">
                  <a16:creationId xmlns:a16="http://schemas.microsoft.com/office/drawing/2014/main" id="{7E83C65F-6016-4224-B46D-4B3AC52081C9}"/>
                </a:ext>
              </a:extLst>
            </p:cNvPr>
            <p:cNvGrpSpPr/>
            <p:nvPr/>
          </p:nvGrpSpPr>
          <p:grpSpPr>
            <a:xfrm>
              <a:off x="9889919" y="1930453"/>
              <a:ext cx="2144376" cy="1566606"/>
              <a:chOff x="9774014" y="2449321"/>
              <a:chExt cx="2144376" cy="1633271"/>
            </a:xfrm>
          </p:grpSpPr>
          <p:pic>
            <p:nvPicPr>
              <p:cNvPr id="18" name="Imagem 17">
                <a:extLst>
                  <a:ext uri="{FF2B5EF4-FFF2-40B4-BE49-F238E27FC236}">
                    <a16:creationId xmlns:a16="http://schemas.microsoft.com/office/drawing/2014/main" id="{5E2E3BE4-D8DF-45CE-80E8-69E01C7511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89893" y="2970554"/>
                <a:ext cx="228632" cy="257211"/>
              </a:xfrm>
              <a:prstGeom prst="rect">
                <a:avLst/>
              </a:prstGeom>
            </p:spPr>
          </p:pic>
          <p:pic>
            <p:nvPicPr>
              <p:cNvPr id="22" name="Imagem 21">
                <a:extLst>
                  <a:ext uri="{FF2B5EF4-FFF2-40B4-BE49-F238E27FC236}">
                    <a16:creationId xmlns:a16="http://schemas.microsoft.com/office/drawing/2014/main" id="{36557F51-4591-406D-A74B-AA0F869747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4014" y="2469841"/>
                <a:ext cx="257211" cy="266737"/>
              </a:xfrm>
              <a:prstGeom prst="rect">
                <a:avLst/>
              </a:prstGeom>
            </p:spPr>
          </p:pic>
          <p:pic>
            <p:nvPicPr>
              <p:cNvPr id="24" name="Imagem 23">
                <a:extLst>
                  <a:ext uri="{FF2B5EF4-FFF2-40B4-BE49-F238E27FC236}">
                    <a16:creationId xmlns:a16="http://schemas.microsoft.com/office/drawing/2014/main" id="{53327AEA-8B5E-4FB8-94DB-CA62964753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03144" y="3424340"/>
                <a:ext cx="238158" cy="228632"/>
              </a:xfrm>
              <a:prstGeom prst="rect">
                <a:avLst/>
              </a:prstGeom>
            </p:spPr>
          </p:pic>
          <p:sp>
            <p:nvSpPr>
              <p:cNvPr id="30" name="CaixaDeTexto 29">
                <a:extLst>
                  <a:ext uri="{FF2B5EF4-FFF2-40B4-BE49-F238E27FC236}">
                    <a16:creationId xmlns:a16="http://schemas.microsoft.com/office/drawing/2014/main" id="{F3C4E3DD-1D10-4D5A-81CD-763ECE650A65}"/>
                  </a:ext>
                </a:extLst>
              </p:cNvPr>
              <p:cNvSpPr txBox="1"/>
              <p:nvPr/>
            </p:nvSpPr>
            <p:spPr>
              <a:xfrm>
                <a:off x="10005825" y="2449321"/>
                <a:ext cx="18871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Very good</a:t>
                </a:r>
                <a:endParaRPr lang="pt-BR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" name="CaixaDeTexto 30">
                <a:extLst>
                  <a:ext uri="{FF2B5EF4-FFF2-40B4-BE49-F238E27FC236}">
                    <a16:creationId xmlns:a16="http://schemas.microsoft.com/office/drawing/2014/main" id="{07AE9398-1881-469F-951D-29ADA2B178B6}"/>
                  </a:ext>
                </a:extLst>
              </p:cNvPr>
              <p:cNvSpPr txBox="1"/>
              <p:nvPr/>
            </p:nvSpPr>
            <p:spPr>
              <a:xfrm>
                <a:off x="10005824" y="2945271"/>
                <a:ext cx="18871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Adequate</a:t>
                </a:r>
                <a:endParaRPr lang="pt-BR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2" name="CaixaDeTexto 31">
                <a:extLst>
                  <a:ext uri="{FF2B5EF4-FFF2-40B4-BE49-F238E27FC236}">
                    <a16:creationId xmlns:a16="http://schemas.microsoft.com/office/drawing/2014/main" id="{F663FA82-1B76-4B5E-939C-AED05F0BEF2C}"/>
                  </a:ext>
                </a:extLst>
              </p:cNvPr>
              <p:cNvSpPr txBox="1"/>
              <p:nvPr/>
            </p:nvSpPr>
            <p:spPr>
              <a:xfrm>
                <a:off x="10018525" y="3413152"/>
                <a:ext cx="1887165" cy="3208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Not reported </a:t>
                </a:r>
                <a:endParaRPr lang="pt-BR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" name="CaixaDeTexto 13">
                <a:extLst>
                  <a:ext uri="{FF2B5EF4-FFF2-40B4-BE49-F238E27FC236}">
                    <a16:creationId xmlns:a16="http://schemas.microsoft.com/office/drawing/2014/main" id="{559545BB-4BA5-4679-B338-FBC782E75B16}"/>
                  </a:ext>
                </a:extLst>
              </p:cNvPr>
              <p:cNvSpPr txBox="1"/>
              <p:nvPr/>
            </p:nvSpPr>
            <p:spPr>
              <a:xfrm>
                <a:off x="10031225" y="3761718"/>
                <a:ext cx="1887165" cy="3208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Not applicable</a:t>
                </a:r>
                <a:endParaRPr lang="pt-BR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41" name="Retângulo 40">
              <a:extLst>
                <a:ext uri="{FF2B5EF4-FFF2-40B4-BE49-F238E27FC236}">
                  <a16:creationId xmlns:a16="http://schemas.microsoft.com/office/drawing/2014/main" id="{E8A81436-72F3-4CB4-A547-1F9C42D619E7}"/>
                </a:ext>
              </a:extLst>
            </p:cNvPr>
            <p:cNvSpPr/>
            <p:nvPr/>
          </p:nvSpPr>
          <p:spPr>
            <a:xfrm>
              <a:off x="9932371" y="3220210"/>
              <a:ext cx="206405" cy="228632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pic>
        <p:nvPicPr>
          <p:cNvPr id="33" name="Imagem 32" descr="Recorte de Tela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266" y="1090128"/>
            <a:ext cx="6984000" cy="4128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3509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75C7742CF67B94693F52F21A125A5B9" ma:contentTypeVersion="9" ma:contentTypeDescription="Crie um novo documento." ma:contentTypeScope="" ma:versionID="afc06e8ea8857c19f596d7acf31c3260">
  <xsd:schema xmlns:xsd="http://www.w3.org/2001/XMLSchema" xmlns:xs="http://www.w3.org/2001/XMLSchema" xmlns:p="http://schemas.microsoft.com/office/2006/metadata/properties" xmlns:ns3="4302c49d-1ee8-4285-a759-5aa42ebc0471" targetNamespace="http://schemas.microsoft.com/office/2006/metadata/properties" ma:root="true" ma:fieldsID="edaaa1ba61a427f0780317294310f016" ns3:_="">
    <xsd:import namespace="4302c49d-1ee8-4285-a759-5aa42ebc047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02c49d-1ee8-4285-a759-5aa42ebc04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5CDD9DC-B8CC-4428-A59B-A35AB1B19518}">
  <ds:schemaRefs>
    <ds:schemaRef ds:uri="http://purl.org/dc/elements/1.1/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http://purl.org/dc/terms/"/>
    <ds:schemaRef ds:uri="http://schemas.microsoft.com/office/2006/documentManagement/types"/>
    <ds:schemaRef ds:uri="4302c49d-1ee8-4285-a759-5aa42ebc0471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034A061-1054-4EEB-8714-1B690391EE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02c49d-1ee8-4285-a759-5aa42ebc047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E31016A-6D52-4285-B55F-7F5286E830E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6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MILA OSPINA AYALA</dc:creator>
  <cp:lastModifiedBy>Rita Mattiello</cp:lastModifiedBy>
  <cp:revision>8</cp:revision>
  <dcterms:created xsi:type="dcterms:W3CDTF">2021-10-29T14:39:58Z</dcterms:created>
  <dcterms:modified xsi:type="dcterms:W3CDTF">2022-03-08T20:5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75C7742CF67B94693F52F21A125A5B9</vt:lpwstr>
  </property>
</Properties>
</file>